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47FBD-C67E-45F3-8D67-1DEDF31D8E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AE75C6-8007-499F-878A-3297379CD5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B763D-1626-402E-8677-C2CA3FB7F8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83068F-E8FE-4E3B-9837-525AEB2691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7BC188-8A23-4B19-9FE9-B859791E5C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8EC32-C505-4F44-84A8-076CBEE55C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59224-E554-49C8-A4A4-6FCA775AFD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A9FE9-1DBE-4B13-9D36-B4876E8B84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EBE274-0B5A-4BF8-B943-AF4C7D92F6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3907A-4AFE-42EB-A61A-835489266B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038F5-3614-4CA5-804E-EE5BB55ADB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A12AF-FF69-45DA-B6AB-A98290F6A2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C0C476-A1C0-4723-94AE-002BFA91A110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0"/>
          <p:cNvGrpSpPr/>
          <p:nvPr/>
        </p:nvGrpSpPr>
        <p:grpSpPr>
          <a:xfrm>
            <a:off x="2760840" y="1782000"/>
            <a:ext cx="6675120" cy="3323880"/>
            <a:chOff x="2760840" y="1782000"/>
            <a:chExt cx="6675120" cy="3323880"/>
          </a:xfrm>
        </p:grpSpPr>
        <p:sp>
          <p:nvSpPr>
            <p:cNvPr id="42" name="Textfeld 1"/>
            <p:cNvSpPr/>
            <p:nvPr/>
          </p:nvSpPr>
          <p:spPr>
            <a:xfrm rot="3576600">
              <a:off x="3400200" y="4578480"/>
              <a:ext cx="79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NCIB36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Textfeld 2"/>
            <p:cNvSpPr/>
            <p:nvPr/>
          </p:nvSpPr>
          <p:spPr>
            <a:xfrm>
              <a:off x="8679960" y="3245400"/>
              <a:ext cx="75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Helveltica"/>
                </a:rPr>
                <a:t>α</a:t>
              </a: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ap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feld 3"/>
            <p:cNvSpPr/>
            <p:nvPr/>
          </p:nvSpPr>
          <p:spPr>
            <a:xfrm>
              <a:off x="8679960" y="3861360"/>
              <a:ext cx="75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Helveltica"/>
                </a:rPr>
                <a:t>α</a:t>
              </a: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Sin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feld 4"/>
            <p:cNvSpPr/>
            <p:nvPr/>
          </p:nvSpPr>
          <p:spPr>
            <a:xfrm rot="3576600">
              <a:off x="385416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92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feld 5"/>
            <p:cNvSpPr/>
            <p:nvPr/>
          </p:nvSpPr>
          <p:spPr>
            <a:xfrm rot="3576600">
              <a:off x="425880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165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feld 6"/>
            <p:cNvSpPr/>
            <p:nvPr/>
          </p:nvSpPr>
          <p:spPr>
            <a:xfrm rot="3576600">
              <a:off x="463428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165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feld 7"/>
            <p:cNvSpPr/>
            <p:nvPr/>
          </p:nvSpPr>
          <p:spPr>
            <a:xfrm rot="3576600">
              <a:off x="531648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84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feld 8"/>
            <p:cNvSpPr/>
            <p:nvPr/>
          </p:nvSpPr>
          <p:spPr>
            <a:xfrm rot="3576600">
              <a:off x="569988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84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feld 9"/>
            <p:cNvSpPr/>
            <p:nvPr/>
          </p:nvSpPr>
          <p:spPr>
            <a:xfrm rot="3576600">
              <a:off x="611280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166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feld 10"/>
            <p:cNvSpPr/>
            <p:nvPr/>
          </p:nvSpPr>
          <p:spPr>
            <a:xfrm rot="3576600">
              <a:off x="687096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156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feld 11"/>
            <p:cNvSpPr/>
            <p:nvPr/>
          </p:nvSpPr>
          <p:spPr>
            <a:xfrm rot="3576600">
              <a:off x="729144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157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feld 12"/>
            <p:cNvSpPr/>
            <p:nvPr/>
          </p:nvSpPr>
          <p:spPr>
            <a:xfrm rot="3576600">
              <a:off x="767808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16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feld 13"/>
            <p:cNvSpPr/>
            <p:nvPr/>
          </p:nvSpPr>
          <p:spPr>
            <a:xfrm rot="3576600">
              <a:off x="8069400" y="45320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GP182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5" name="Grafik 14" descr=""/>
            <p:cNvPicPr/>
            <p:nvPr/>
          </p:nvPicPr>
          <p:blipFill>
            <a:blip r:embed="rId1"/>
            <a:srcRect l="24892" t="12895" r="46985" b="76887"/>
            <a:stretch/>
          </p:blipFill>
          <p:spPr>
            <a:xfrm>
              <a:off x="3485880" y="3129120"/>
              <a:ext cx="1623600" cy="397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6" name="Grafik 15" descr=""/>
            <p:cNvPicPr/>
            <p:nvPr/>
          </p:nvPicPr>
          <p:blipFill>
            <a:blip r:embed="rId2"/>
            <a:srcRect l="5031" t="32227" r="4600" b="31309"/>
            <a:stretch/>
          </p:blipFill>
          <p:spPr>
            <a:xfrm>
              <a:off x="5297040" y="3133440"/>
              <a:ext cx="3294720" cy="397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7" name="Grafik 16" descr=""/>
            <p:cNvPicPr/>
            <p:nvPr/>
          </p:nvPicPr>
          <p:blipFill>
            <a:blip r:embed="rId3"/>
            <a:srcRect l="26252" t="11844" r="43992" b="78125"/>
            <a:stretch/>
          </p:blipFill>
          <p:spPr>
            <a:xfrm>
              <a:off x="3402720" y="3842280"/>
              <a:ext cx="1717920" cy="3906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8" name="Grafik 17" descr=""/>
            <p:cNvPicPr/>
            <p:nvPr/>
          </p:nvPicPr>
          <p:blipFill>
            <a:blip r:embed="rId4"/>
            <a:srcRect l="25809" t="55737" r="16425" b="32408"/>
            <a:stretch/>
          </p:blipFill>
          <p:spPr>
            <a:xfrm>
              <a:off x="5290920" y="3753720"/>
              <a:ext cx="3335040" cy="4615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9" name="Textfeld 18"/>
            <p:cNvSpPr/>
            <p:nvPr/>
          </p:nvSpPr>
          <p:spPr>
            <a:xfrm rot="3576600">
              <a:off x="278964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wild typ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feld 19"/>
            <p:cNvSpPr/>
            <p:nvPr/>
          </p:nvSpPr>
          <p:spPr>
            <a:xfrm rot="3576600">
              <a:off x="317916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∆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Helveltica"/>
                </a:rPr>
                <a:t>ymd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feld 20"/>
            <p:cNvSpPr/>
            <p:nvPr/>
          </p:nvSpPr>
          <p:spPr>
            <a:xfrm rot="3576600">
              <a:off x="363456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∆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Helveltica"/>
                </a:rPr>
                <a:t>ymdB </a:t>
              </a: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SinR: S43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feld 21"/>
            <p:cNvSpPr/>
            <p:nvPr/>
          </p:nvSpPr>
          <p:spPr>
            <a:xfrm rot="3576600">
              <a:off x="3922560" y="2326680"/>
              <a:ext cx="140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∆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Helveltica"/>
                </a:rPr>
                <a:t>ymdB </a:t>
              </a: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SinR: W104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feld 22"/>
            <p:cNvSpPr/>
            <p:nvPr/>
          </p:nvSpPr>
          <p:spPr>
            <a:xfrm rot="3576600">
              <a:off x="464220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wild typ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feld 23"/>
            <p:cNvSpPr/>
            <p:nvPr/>
          </p:nvSpPr>
          <p:spPr>
            <a:xfrm rot="3576600">
              <a:off x="506088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∆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Helveltica"/>
                </a:rPr>
                <a:t>ymd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feld 24"/>
            <p:cNvSpPr/>
            <p:nvPr/>
          </p:nvSpPr>
          <p:spPr>
            <a:xfrm rot="3576600">
              <a:off x="5423040" y="2342160"/>
              <a:ext cx="136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∆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Helveltica"/>
                </a:rPr>
                <a:t>ymdB </a:t>
              </a: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SinR: W104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feld 25"/>
            <p:cNvSpPr/>
            <p:nvPr/>
          </p:nvSpPr>
          <p:spPr>
            <a:xfrm rot="3576600">
              <a:off x="624060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wild typ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feld 26"/>
            <p:cNvSpPr/>
            <p:nvPr/>
          </p:nvSpPr>
          <p:spPr>
            <a:xfrm rot="3576600">
              <a:off x="662256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∆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Helveltica"/>
                </a:rPr>
                <a:t>ymd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feld 27"/>
            <p:cNvSpPr/>
            <p:nvPr/>
          </p:nvSpPr>
          <p:spPr>
            <a:xfrm rot="3576600">
              <a:off x="709668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∆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Helveltica"/>
                </a:rPr>
                <a:t>ymdB </a:t>
              </a: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SinR: A85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feld 28"/>
            <p:cNvSpPr/>
            <p:nvPr/>
          </p:nvSpPr>
          <p:spPr>
            <a:xfrm rot="3576600">
              <a:off x="7484040" y="237312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∆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Helveltica"/>
                </a:rPr>
                <a:t>ymdB </a:t>
              </a: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SinR: K28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feld 29"/>
            <p:cNvSpPr/>
            <p:nvPr/>
          </p:nvSpPr>
          <p:spPr>
            <a:xfrm>
              <a:off x="2760840" y="4532040"/>
              <a:ext cx="79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Helveltica"/>
                </a:rPr>
                <a:t>Stra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18T10:22:31Z</dcterms:created>
  <dc:creator>Robert Cleverley</dc:creator>
  <dc:description/>
  <dc:language>en-US</dc:language>
  <cp:lastModifiedBy>nrl7</cp:lastModifiedBy>
  <dcterms:modified xsi:type="dcterms:W3CDTF">2018-07-05T12:52:45Z</dcterms:modified>
  <cp:revision>11</cp:revision>
  <dc:subject/>
  <dc:title>PowerPoint Presentation</dc:title>
</cp:coreProperties>
</file>